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60" r:id="rId4"/>
    <p:sldId id="261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076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722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72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551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3691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8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8700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0538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9363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505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7854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40DCF-3940-44F2-9B7F-C6B11C4B8F39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2249FD-AA60-4F15-A89C-A42842F3702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6943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67" r="26236" b="62772"/>
          <a:stretch/>
        </p:blipFill>
        <p:spPr>
          <a:xfrm>
            <a:off x="2491534" y="2770094"/>
            <a:ext cx="3999570" cy="22456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6491104" y="3708258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506072" y="2329636"/>
            <a:ext cx="12458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ox (ng/ml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859502" y="2329636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603570" y="232963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213168" y="232963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674849" y="232963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217212" y="232963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786469" y="2329636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188180" y="1840474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55647" y="510989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a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2537312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24" t="10791" r="20274" b="47160"/>
          <a:stretch/>
        </p:blipFill>
        <p:spPr>
          <a:xfrm>
            <a:off x="1685434" y="2503528"/>
            <a:ext cx="5818024" cy="29828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7503458" y="3785344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66481" y="2165575"/>
            <a:ext cx="12505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ox (ng/ml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111189" y="2165575"/>
            <a:ext cx="295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626658" y="2165575"/>
            <a:ext cx="295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980763" y="2165575"/>
            <a:ext cx="295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406584" y="2165575"/>
            <a:ext cx="421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841366" y="2165575"/>
            <a:ext cx="5244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329946" y="2165575"/>
            <a:ext cx="4437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724392" y="2165575"/>
            <a:ext cx="4437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127802" y="2165575"/>
            <a:ext cx="4437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549142" y="2165575"/>
            <a:ext cx="4437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983928" y="2165575"/>
            <a:ext cx="5378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418715" y="2165575"/>
            <a:ext cx="676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947631" y="2165575"/>
            <a:ext cx="676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164523" y="332141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1508375" y="3477249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1155559" y="476473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1499411" y="4920561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3027350" y="1442601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GRB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55647" y="510989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a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187776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84" t="24382" r="27961" b="38272"/>
          <a:stretch/>
        </p:blipFill>
        <p:spPr>
          <a:xfrm>
            <a:off x="2662516" y="2770093"/>
            <a:ext cx="3089157" cy="17884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文本框 9"/>
          <p:cNvSpPr txBox="1"/>
          <p:nvPr/>
        </p:nvSpPr>
        <p:spPr>
          <a:xfrm>
            <a:off x="2796984" y="415085"/>
            <a:ext cx="2993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653983" y="2447962"/>
            <a:ext cx="12505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ox (ng/ml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402101" y="2447962"/>
            <a:ext cx="295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823441" y="2447962"/>
            <a:ext cx="295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177546" y="2447962"/>
            <a:ext cx="2958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513723" y="2437490"/>
            <a:ext cx="4437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275720" y="2437490"/>
            <a:ext cx="676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876793" y="2441973"/>
            <a:ext cx="676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790111" y="3495045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49573" y="1243863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a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 rot="17787284">
            <a:off x="2788015" y="2179022"/>
            <a:ext cx="986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mpty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46736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520082" y="1082499"/>
            <a:ext cx="49231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a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7827" y="2116567"/>
            <a:ext cx="3407664" cy="3108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7259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</TotalTime>
  <Words>75</Words>
  <Application>Microsoft Office PowerPoint</Application>
  <PresentationFormat>全屏显示(4:3)</PresentationFormat>
  <Paragraphs>4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9</cp:revision>
  <dcterms:created xsi:type="dcterms:W3CDTF">2020-08-31T06:07:18Z</dcterms:created>
  <dcterms:modified xsi:type="dcterms:W3CDTF">2020-10-09T02:28:51Z</dcterms:modified>
</cp:coreProperties>
</file>